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47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1991432-16D4-A338-8C74-AA5AE8E7A6BA}" name="BeKa Leuschen-Kohl" initials="BLK" userId="BeKa Leuschen-Kohl" providerId="None"/>
  <p188:author id="{152ED23C-9289-3640-DC9D-A0185063BC84}" name="Iyer-Pascuzzi, Anjali" initials="IA" userId="S::aiyerpas@purdue.edu::dcf03dc3-b88b-4fb8-8f79-4d9cab98b2b3" providerId="AD"/>
  <p188:author id="{22EA6AEE-A713-B989-205E-2187CD1F1D1A}" name="Rebecca Lynn Leuschen-kohl" initials="RL" userId="S::rleusche@purdue.edu::00225fb4-0928-44a2-820d-794618e88d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BDBD"/>
    <a:srgbClr val="949F95"/>
    <a:srgbClr val="DEDEDE"/>
    <a:srgbClr val="ADB9CA"/>
    <a:srgbClr val="FFFFFF"/>
    <a:srgbClr val="4F4390"/>
    <a:srgbClr val="FFBDDE"/>
    <a:srgbClr val="B3B3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41" d="100"/>
          <a:sy n="41" d="100"/>
        </p:scale>
        <p:origin x="1308" y="-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becca Leuschen-Kohl" userId="ef62846a7a2008e6" providerId="LiveId" clId="{A38BEADC-B95B-469E-8EA4-2C39AB3F3628}"/>
    <pc:docChg chg="delSld">
      <pc:chgData name="Rebecca Leuschen-Kohl" userId="ef62846a7a2008e6" providerId="LiveId" clId="{A38BEADC-B95B-469E-8EA4-2C39AB3F3628}" dt="2024-11-05T00:39:09.909" v="4" actId="47"/>
      <pc:docMkLst>
        <pc:docMk/>
      </pc:docMkLst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830658197" sldId="332"/>
        </pc:sldMkLst>
      </pc:sldChg>
      <pc:sldChg chg="del">
        <pc:chgData name="Rebecca Leuschen-Kohl" userId="ef62846a7a2008e6" providerId="LiveId" clId="{A38BEADC-B95B-469E-8EA4-2C39AB3F3628}" dt="2024-11-05T00:39:04.393" v="2" actId="47"/>
        <pc:sldMkLst>
          <pc:docMk/>
          <pc:sldMk cId="3398032437" sldId="336"/>
        </pc:sldMkLst>
      </pc:sldChg>
      <pc:sldChg chg="del">
        <pc:chgData name="Rebecca Leuschen-Kohl" userId="ef62846a7a2008e6" providerId="LiveId" clId="{A38BEADC-B95B-469E-8EA4-2C39AB3F3628}" dt="2024-11-05T00:39:05.129" v="3" actId="47"/>
        <pc:sldMkLst>
          <pc:docMk/>
          <pc:sldMk cId="3793326182" sldId="338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1961722243" sldId="339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830734933" sldId="348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397969387" sldId="349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1704172087" sldId="351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3486478879" sldId="353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2478473178" sldId="354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2416863298" sldId="355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568157699" sldId="356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1185421222" sldId="359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83140915" sldId="361"/>
        </pc:sldMkLst>
      </pc:sldChg>
      <pc:sldChg chg="del">
        <pc:chgData name="Rebecca Leuschen-Kohl" userId="ef62846a7a2008e6" providerId="LiveId" clId="{A38BEADC-B95B-469E-8EA4-2C39AB3F3628}" dt="2024-11-05T00:39:03.949" v="1" actId="47"/>
        <pc:sldMkLst>
          <pc:docMk/>
          <pc:sldMk cId="58006295" sldId="363"/>
        </pc:sldMkLst>
      </pc:sldChg>
      <pc:sldChg chg="del">
        <pc:chgData name="Rebecca Leuschen-Kohl" userId="ef62846a7a2008e6" providerId="LiveId" clId="{A38BEADC-B95B-469E-8EA4-2C39AB3F3628}" dt="2024-11-05T00:39:03.448" v="0" actId="47"/>
        <pc:sldMkLst>
          <pc:docMk/>
          <pc:sldMk cId="4206593612" sldId="364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2301688996" sldId="365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471017098" sldId="366"/>
        </pc:sldMkLst>
      </pc:sldChg>
      <pc:sldChg chg="del">
        <pc:chgData name="Rebecca Leuschen-Kohl" userId="ef62846a7a2008e6" providerId="LiveId" clId="{A38BEADC-B95B-469E-8EA4-2C39AB3F3628}" dt="2024-11-05T00:39:09.909" v="4" actId="47"/>
        <pc:sldMkLst>
          <pc:docMk/>
          <pc:sldMk cId="1752517358" sldId="36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5C9A0A-66B1-4FAF-A1C5-2E9142573E35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C2AFF7-3C64-424C-82FD-976B3E97E4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765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C2AFF7-3C64-424C-82FD-976B3E97E48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6858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69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048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0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40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863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995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65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035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408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661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620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61ED3-D41B-4A2F-90AC-239322BE671F}" type="datetimeFigureOut">
              <a:rPr lang="en-US" smtClean="0"/>
              <a:t>1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A9427-4F86-44AA-9A4C-1D4AB0B01C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83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446EB84-B0BE-B6DC-9476-52D436A17E64}"/>
              </a:ext>
            </a:extLst>
          </p:cNvPr>
          <p:cNvSpPr txBox="1"/>
          <p:nvPr/>
        </p:nvSpPr>
        <p:spPr>
          <a:xfrm>
            <a:off x="910691" y="563430"/>
            <a:ext cx="548640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274012"/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 LA0176 does not respond to csp22</a:t>
            </a:r>
            <a:r>
              <a:rPr lang="en-US" sz="1000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sol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  <a:p>
            <a:pPr defTabSz="274012"/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Change in root growth (cm/24 hour) for tomato roots of LA0176 from 0-24 hours and 24-48 hours. Tomato seedlings treated with 1 µM csp22</a:t>
            </a: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sol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 mock (water). </a:t>
            </a:r>
            <a:r>
              <a:rPr lang="en-US" sz="10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the mean ±SD from at least 18 replicates per treatment.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ent’s t-test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*</a:t>
            </a:r>
            <a:r>
              <a:rPr lang="en-US" sz="10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&lt;0.05, **p&lt;0.01, ***p&lt;0.001, ****p&lt;0.0001) </a:t>
            </a:r>
            <a:r>
              <a:rPr lang="en-US" sz="1000" b="1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lang="en-US" sz="10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oot samples from 5-day-old tomato seedlings of H7996 were treated with 1 µM csp22</a:t>
            </a: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sol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 mock (water). </a:t>
            </a:r>
            <a:r>
              <a:rPr lang="en-US" sz="10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lues represent the mean ± SD from at least 6 replicates per treatment. The experiment was repeated three times with similar results. </a:t>
            </a: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 descr="A graph and diagram of a person&#10;&#10;Description automatically generated with medium confidence">
            <a:extLst>
              <a:ext uri="{FF2B5EF4-FFF2-40B4-BE49-F238E27FC236}">
                <a16:creationId xmlns:a16="http://schemas.microsoft.com/office/drawing/2014/main" id="{E2AE5E21-0804-EF03-BE3F-4B310E41B93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288" y="2677885"/>
            <a:ext cx="6611823" cy="33059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9073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56102D0D35E964BBFE2C79D04696EE4" ma:contentTypeVersion="18" ma:contentTypeDescription="Create a new document." ma:contentTypeScope="" ma:versionID="71fc2afbc31600472ab73e35b249ead8">
  <xsd:schema xmlns:xsd="http://www.w3.org/2001/XMLSchema" xmlns:xs="http://www.w3.org/2001/XMLSchema" xmlns:p="http://schemas.microsoft.com/office/2006/metadata/properties" xmlns:ns2="974c5d5a-69c4-47c0-8134-bb286fa4472c" xmlns:ns3="746cde4b-492d-48ba-92d7-9676a22a1012" targetNamespace="http://schemas.microsoft.com/office/2006/metadata/properties" ma:root="true" ma:fieldsID="23e452dd77b66b46fbeaa7a26eb6c6ab" ns2:_="" ns3:_="">
    <xsd:import namespace="974c5d5a-69c4-47c0-8134-bb286fa4472c"/>
    <xsd:import namespace="746cde4b-492d-48ba-92d7-9676a22a101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4c5d5a-69c4-47c0-8134-bb286fa447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e9e90a8-b24c-4be7-8760-a88b2cd47e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6cde4b-492d-48ba-92d7-9676a22a1012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f532aa21-857b-4867-95d0-9dc152152f45}" ma:internalName="TaxCatchAll" ma:showField="CatchAllData" ma:web="746cde4b-492d-48ba-92d7-9676a22a101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74c5d5a-69c4-47c0-8134-bb286fa4472c">
      <Terms xmlns="http://schemas.microsoft.com/office/infopath/2007/PartnerControls"/>
    </lcf76f155ced4ddcb4097134ff3c332f>
    <TaxCatchAll xmlns="746cde4b-492d-48ba-92d7-9676a22a1012" xsi:nil="true"/>
  </documentManagement>
</p:properties>
</file>

<file path=customXml/itemProps1.xml><?xml version="1.0" encoding="utf-8"?>
<ds:datastoreItem xmlns:ds="http://schemas.openxmlformats.org/officeDocument/2006/customXml" ds:itemID="{34E92243-6744-4250-8C81-06A634B89881}">
  <ds:schemaRefs>
    <ds:schemaRef ds:uri="746cde4b-492d-48ba-92d7-9676a22a1012"/>
    <ds:schemaRef ds:uri="974c5d5a-69c4-47c0-8134-bb286fa4472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986C45CB-9F98-4FBA-95D4-669FBCC50C6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313B5D3-9FE6-4906-868D-5CC357E257CA}">
  <ds:schemaRefs>
    <ds:schemaRef ds:uri="974c5d5a-69c4-47c0-8134-bb286fa4472c"/>
    <ds:schemaRef ds:uri="http://schemas.microsoft.com/office/2006/documentManagement/types"/>
    <ds:schemaRef ds:uri="http://www.w3.org/XML/1998/namespace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746cde4b-492d-48ba-92d7-9676a22a1012"/>
    <ds:schemaRef ds:uri="http://schemas.microsoft.com/office/2006/metadata/properties"/>
    <ds:schemaRef ds:uri="http://purl.org/dc/dcmitype/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67</TotalTime>
  <Words>132</Words>
  <Application>Microsoft Office PowerPoint</Application>
  <PresentationFormat>Custom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!</dc:title>
  <dc:creator>BeKa Leuschen</dc:creator>
  <cp:lastModifiedBy>BeKa Leuschen-Kohl</cp:lastModifiedBy>
  <cp:revision>3</cp:revision>
  <dcterms:created xsi:type="dcterms:W3CDTF">2022-01-14T17:50:55Z</dcterms:created>
  <dcterms:modified xsi:type="dcterms:W3CDTF">2024-11-05T00:39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56102D0D35E964BBFE2C79D04696EE4</vt:lpwstr>
  </property>
  <property fmtid="{D5CDD505-2E9C-101B-9397-08002B2CF9AE}" pid="3" name="MediaServiceImageTags">
    <vt:lpwstr/>
  </property>
  <property fmtid="{D5CDD505-2E9C-101B-9397-08002B2CF9AE}" pid="4" name="MSIP_Label_4044bd30-2ed7-4c9d-9d12-46200872a97b_Enabled">
    <vt:lpwstr>true</vt:lpwstr>
  </property>
  <property fmtid="{D5CDD505-2E9C-101B-9397-08002B2CF9AE}" pid="5" name="MSIP_Label_4044bd30-2ed7-4c9d-9d12-46200872a97b_SetDate">
    <vt:lpwstr>2022-12-15T15:50:22Z</vt:lpwstr>
  </property>
  <property fmtid="{D5CDD505-2E9C-101B-9397-08002B2CF9AE}" pid="6" name="MSIP_Label_4044bd30-2ed7-4c9d-9d12-46200872a97b_Method">
    <vt:lpwstr>Standard</vt:lpwstr>
  </property>
  <property fmtid="{D5CDD505-2E9C-101B-9397-08002B2CF9AE}" pid="7" name="MSIP_Label_4044bd30-2ed7-4c9d-9d12-46200872a97b_Name">
    <vt:lpwstr>defa4170-0d19-0005-0004-bc88714345d2</vt:lpwstr>
  </property>
  <property fmtid="{D5CDD505-2E9C-101B-9397-08002B2CF9AE}" pid="8" name="MSIP_Label_4044bd30-2ed7-4c9d-9d12-46200872a97b_SiteId">
    <vt:lpwstr>4130bd39-7c53-419c-b1e5-8758d6d63f21</vt:lpwstr>
  </property>
  <property fmtid="{D5CDD505-2E9C-101B-9397-08002B2CF9AE}" pid="9" name="MSIP_Label_4044bd30-2ed7-4c9d-9d12-46200872a97b_ActionId">
    <vt:lpwstr>f1376b59-ccc7-4a7c-91ca-02a5a8238883</vt:lpwstr>
  </property>
  <property fmtid="{D5CDD505-2E9C-101B-9397-08002B2CF9AE}" pid="10" name="MSIP_Label_4044bd30-2ed7-4c9d-9d12-46200872a97b_ContentBits">
    <vt:lpwstr>0</vt:lpwstr>
  </property>
</Properties>
</file>